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5840"/>
  </p:normalViewPr>
  <p:slideViewPr>
    <p:cSldViewPr snapToGrid="0">
      <p:cViewPr varScale="1">
        <p:scale>
          <a:sx n="112" d="100"/>
          <a:sy n="112" d="100"/>
        </p:scale>
        <p:origin x="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AEFA3-2A29-AFBA-4FC7-BA1ECA22AA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6F3BCC-671D-0884-9A4E-A8BEFF85CD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BE0289-3565-44A7-CB45-A3E054FB6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05CE42-9E37-D60A-BDEA-9BCA0A997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6B5536-7240-3CF4-AAF8-A63E87B6E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554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53564-FF6B-A664-E673-093F933B87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0A884C-6D50-201F-E788-E65C28060C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298682-A4DF-6D30-4BA6-63C2179EC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E8092D-D7B6-EFC1-3937-55B7BD619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879F05-FE7C-278B-5AD4-3D420D1BA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280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2B82CD-A264-C778-F098-793BAAF066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FC9561-8A71-2285-F986-7E78155D3E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CB57C6-2E32-B8D8-74BA-869031F9E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FB135C-39D4-AF09-C3C4-71612CFD1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D9FCBF-1C45-83E0-8322-8CBF5DD47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581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F8292-89A7-5CFE-FF0E-60BA6C707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3D40A3-95E6-56EA-42CD-5B3D8446F6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A768D8-AD64-08FB-00F6-466DDA4E3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A7B09F-2EB2-30E2-2DC0-37933444F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7C1CFA-B6D8-4E48-46F0-5BAB42218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054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FFAD2-A800-2F26-3941-E3B29EE870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86BA3C-0BA7-4B55-07F1-188C8BB79A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5E480F-AF04-F006-E2ED-643BAD361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58645-331C-A1C1-E162-4EDB913A7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B1703-A837-42DC-88CA-F61D3DA2F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261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65B002-73AA-D690-511E-0DB2BF98AC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2477A1-3A08-26F7-7D1E-05A70042AC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3D7482-5DEF-B6C0-A1FD-978DC9D668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31340D-E7A1-5FCA-7140-7D005692B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0FBD34-EC9F-C8C1-E6CA-CF7762AAD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A8451D-E4ED-6E5F-B02C-F6FAD4902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951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AB5275-4135-DCF4-4B7A-1759AC36C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804DE-CB44-7B8F-4206-FB6787965F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EC0E84-8CD3-C970-2AA7-46FF6667E9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6F1772-E970-2FD4-9DC7-489517C82E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C0A9F00-F888-4608-2353-9655FC0440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5DC41E-83EC-54B1-89B3-75496BA3F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5B85D5-560F-E54A-3B63-015C83486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C636F9-17EA-10F1-0103-22450CF6B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166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074D2D-4A98-92D3-79A1-49D41D7D2A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224FB7-FAB7-3779-BBCC-A6C7049A1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C1F9EE5-3F8A-BCE7-1F4C-D52793752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9D5D9B-E59D-2FC7-D737-7F7BF6A3E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827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8FCDBC-A4C4-EAE1-2C89-A538A4AE1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E78106-07FD-E8B5-2D6D-413A98FE7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E004F2-142E-D645-8CA7-23A827862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145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C30D9-BB59-5083-38D5-EC9DB17EF1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3EB9B9-B642-B950-045E-AF761F0C0F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E0C8BB-AC7A-4A73-5E84-CAC30281AC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DE300A-FE3F-3D93-848D-C540B5FA0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717F1A-9154-09DF-C6CE-D983627EF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8419C9-A025-1DB9-868D-AC677A410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91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916AF-35D9-D380-96D8-10482FBFC6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D616B9-EA09-D2C1-630B-4EB965D344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AC0D74-FFB0-98F1-ACF4-32419E5E7C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089BF5-E526-92F0-9336-8555D15A4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5B1F68-E46A-6F44-29A6-9B397B4EC3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F740BB-3276-C076-5780-2AAB01C2C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069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DC262DC-D540-D6EF-5376-961BA4C60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86162E-A78D-C7DF-4A95-A336B7CFA8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60B75-7F8C-AE24-FCEB-B038D66BA3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18AC6-8ABF-464E-9893-29B1377777A0}" type="datetimeFigureOut">
              <a:rPr lang="en-US" smtClean="0"/>
              <a:t>1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F13459-DF32-1327-5AF4-8AB88458B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F28CF8-4FC0-076F-B996-AFD6CB75E2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5D070A-B55B-D741-B1F3-FA08C7BA3E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383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B19E112-1304-A593-C27F-A86C11B7A8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1" y="1272751"/>
            <a:ext cx="10034710" cy="341841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F819788-5BA6-9F88-06C8-227F9BB85E6D}"/>
              </a:ext>
            </a:extLst>
          </p:cNvPr>
          <p:cNvSpPr txBox="1"/>
          <p:nvPr/>
        </p:nvSpPr>
        <p:spPr>
          <a:xfrm>
            <a:off x="433092" y="5361517"/>
            <a:ext cx="9072282" cy="14927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 Figure 1. Inhibitory effect of FAHF-2 on IgE production by plasma cell line U266 cells.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A)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266 cells were treated with 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HF-2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different concentrations and cultured for 6 days. Supernatants were collected, and IgE levels were determined by ELISA. (B) 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C</a:t>
            </a:r>
            <a:r>
              <a:rPr lang="en-US" sz="15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0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alues for FAHF-2 was calculated to be 79.7</a:t>
            </a:r>
            <a:r>
              <a:rPr lang="en-US" sz="150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±17.39 </a:t>
            </a:r>
            <a:r>
              <a:rPr lang="el-GR" sz="15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5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</a:t>
            </a:r>
            <a:r>
              <a:rPr lang="en-US" sz="15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L.</a:t>
            </a:r>
            <a:r>
              <a:rPr lang="en-US" sz="15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 Cell viability was measured by trypan blue excursion showed no cell cytotoxicity. IgE levels are expressed as Mean± SEM, and significance is indicated by **p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itchFamily="2" charset="2"/>
              </a:rPr>
              <a:t>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01, and ***p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itchFamily="2" charset="2"/>
              </a:rPr>
              <a:t>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001 as compared to the untreated control. N=9 independent cultures over 3 batches.</a:t>
            </a:r>
            <a:endParaRPr lang="en-US" sz="15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AAE715-60BC-0B6D-A710-B0DA616B0C1F}"/>
              </a:ext>
            </a:extLst>
          </p:cNvPr>
          <p:cNvSpPr txBox="1"/>
          <p:nvPr/>
        </p:nvSpPr>
        <p:spPr>
          <a:xfrm>
            <a:off x="433092" y="294625"/>
            <a:ext cx="6963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l Figure 1 . Inhibitory Effect of FAHF-2 on IgE Production by U266 Cell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4737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1A12F15-853B-D7CD-1824-222CFBB0FF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885" y="806012"/>
            <a:ext cx="8833672" cy="456632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E087A11-84CD-D07C-86DA-69764DDA63FC}"/>
              </a:ext>
            </a:extLst>
          </p:cNvPr>
          <p:cNvSpPr txBox="1"/>
          <p:nvPr/>
        </p:nvSpPr>
        <p:spPr>
          <a:xfrm>
            <a:off x="177885" y="5372340"/>
            <a:ext cx="11580728" cy="12464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 </a:t>
            </a:r>
            <a:r>
              <a:rPr lang="en-US" sz="15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2: </a:t>
            </a:r>
            <a:r>
              <a:rPr kumimoji="0" 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hibitory Effect of FAHF-2 and EBF-2 on IgE Production by U266 Cells between different batches.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266 cells were treated with different batches of 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HF-2- FAFH2-1106 (A), FAFH2-0202 (B) and FAHF2-0909 (C) and EBF-2 batches- EBF-2-0303(D), EBF-2-0808(E), and EBF-2-0130 (F) respectively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different concentrations and cultured for 6 days. Supernatants were collected, and IgE levels were determined by ELISA. 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gE levels are expressed as Mean± SEM, and significance is indicated by *p&lt;0.05, **p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itchFamily="2" charset="2"/>
              </a:rPr>
              <a:t>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01, and ***p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itchFamily="2" charset="2"/>
              </a:rPr>
              <a:t>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001 as compared to the untreated control. N=3 independent cultures. </a:t>
            </a:r>
            <a:endParaRPr lang="en-US" sz="15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004B82-3D59-AC6A-656A-34FCCCAD5A82}"/>
              </a:ext>
            </a:extLst>
          </p:cNvPr>
          <p:cNvSpPr txBox="1"/>
          <p:nvPr/>
        </p:nvSpPr>
        <p:spPr>
          <a:xfrm>
            <a:off x="177885" y="182015"/>
            <a:ext cx="825243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l Figure 2. Inhibitory Effect of FAHF-2 and EBF-2 on IgE Production by U266 Cells between different batches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2898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77</Words>
  <Application>Microsoft Macintosh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 2013 - 2022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sh Maskey</dc:creator>
  <cp:lastModifiedBy>Anish Maskey</cp:lastModifiedBy>
  <cp:revision>1</cp:revision>
  <dcterms:created xsi:type="dcterms:W3CDTF">2023-01-12T11:33:15Z</dcterms:created>
  <dcterms:modified xsi:type="dcterms:W3CDTF">2023-01-12T11:35:23Z</dcterms:modified>
</cp:coreProperties>
</file>